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52" r:id="rId1"/>
  </p:sldMasterIdLst>
  <p:notesMasterIdLst>
    <p:notesMasterId r:id="rId3"/>
  </p:notesMasterIdLst>
  <p:sldIdLst>
    <p:sldId id="256" r:id="rId2"/>
  </p:sldIdLst>
  <p:sldSz cx="14400213" cy="181832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5696" autoAdjust="0"/>
  </p:normalViewPr>
  <p:slideViewPr>
    <p:cSldViewPr snapToGrid="0">
      <p:cViewPr varScale="1">
        <p:scale>
          <a:sx n="39" d="100"/>
          <a:sy n="39" d="100"/>
        </p:scale>
        <p:origin x="308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4557A8-9C08-4C62-8688-C4B8FA228821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6625" y="1143000"/>
            <a:ext cx="2444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BFB99E-A572-4C00-B2FE-B5BCF69B92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7272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55164" rtl="0" eaLnBrk="1" latinLnBrk="0" hangingPunct="1">
      <a:defRPr sz="1647" kern="1200">
        <a:solidFill>
          <a:schemeClr val="tx1"/>
        </a:solidFill>
        <a:latin typeface="+mn-lt"/>
        <a:ea typeface="+mn-ea"/>
        <a:cs typeface="+mn-cs"/>
      </a:defRPr>
    </a:lvl1pPr>
    <a:lvl2pPr marL="627582" algn="l" defTabSz="1255164" rtl="0" eaLnBrk="1" latinLnBrk="0" hangingPunct="1">
      <a:defRPr sz="1647" kern="1200">
        <a:solidFill>
          <a:schemeClr val="tx1"/>
        </a:solidFill>
        <a:latin typeface="+mn-lt"/>
        <a:ea typeface="+mn-ea"/>
        <a:cs typeface="+mn-cs"/>
      </a:defRPr>
    </a:lvl2pPr>
    <a:lvl3pPr marL="1255164" algn="l" defTabSz="1255164" rtl="0" eaLnBrk="1" latinLnBrk="0" hangingPunct="1">
      <a:defRPr sz="1647" kern="1200">
        <a:solidFill>
          <a:schemeClr val="tx1"/>
        </a:solidFill>
        <a:latin typeface="+mn-lt"/>
        <a:ea typeface="+mn-ea"/>
        <a:cs typeface="+mn-cs"/>
      </a:defRPr>
    </a:lvl3pPr>
    <a:lvl4pPr marL="1882747" algn="l" defTabSz="1255164" rtl="0" eaLnBrk="1" latinLnBrk="0" hangingPunct="1">
      <a:defRPr sz="1647" kern="1200">
        <a:solidFill>
          <a:schemeClr val="tx1"/>
        </a:solidFill>
        <a:latin typeface="+mn-lt"/>
        <a:ea typeface="+mn-ea"/>
        <a:cs typeface="+mn-cs"/>
      </a:defRPr>
    </a:lvl4pPr>
    <a:lvl5pPr marL="2510329" algn="l" defTabSz="1255164" rtl="0" eaLnBrk="1" latinLnBrk="0" hangingPunct="1">
      <a:defRPr sz="1647" kern="1200">
        <a:solidFill>
          <a:schemeClr val="tx1"/>
        </a:solidFill>
        <a:latin typeface="+mn-lt"/>
        <a:ea typeface="+mn-ea"/>
        <a:cs typeface="+mn-cs"/>
      </a:defRPr>
    </a:lvl5pPr>
    <a:lvl6pPr marL="3137911" algn="l" defTabSz="1255164" rtl="0" eaLnBrk="1" latinLnBrk="0" hangingPunct="1">
      <a:defRPr sz="1647" kern="1200">
        <a:solidFill>
          <a:schemeClr val="tx1"/>
        </a:solidFill>
        <a:latin typeface="+mn-lt"/>
        <a:ea typeface="+mn-ea"/>
        <a:cs typeface="+mn-cs"/>
      </a:defRPr>
    </a:lvl6pPr>
    <a:lvl7pPr marL="3765493" algn="l" defTabSz="1255164" rtl="0" eaLnBrk="1" latinLnBrk="0" hangingPunct="1">
      <a:defRPr sz="1647" kern="1200">
        <a:solidFill>
          <a:schemeClr val="tx1"/>
        </a:solidFill>
        <a:latin typeface="+mn-lt"/>
        <a:ea typeface="+mn-ea"/>
        <a:cs typeface="+mn-cs"/>
      </a:defRPr>
    </a:lvl7pPr>
    <a:lvl8pPr marL="4393074" algn="l" defTabSz="1255164" rtl="0" eaLnBrk="1" latinLnBrk="0" hangingPunct="1">
      <a:defRPr sz="1647" kern="1200">
        <a:solidFill>
          <a:schemeClr val="tx1"/>
        </a:solidFill>
        <a:latin typeface="+mn-lt"/>
        <a:ea typeface="+mn-ea"/>
        <a:cs typeface="+mn-cs"/>
      </a:defRPr>
    </a:lvl8pPr>
    <a:lvl9pPr marL="5020658" algn="l" defTabSz="1255164" rtl="0" eaLnBrk="1" latinLnBrk="0" hangingPunct="1">
      <a:defRPr sz="164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06625" y="1143000"/>
            <a:ext cx="24447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3BFB99E-A572-4C00-B2FE-B5BCF69B928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89809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2975821"/>
            <a:ext cx="12240181" cy="6330456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9550404"/>
            <a:ext cx="10800160" cy="4390069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1768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2473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968088"/>
            <a:ext cx="3105046" cy="1540944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968088"/>
            <a:ext cx="9135135" cy="1540944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47702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9039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4533184"/>
            <a:ext cx="12420184" cy="7563715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12168455"/>
            <a:ext cx="12420184" cy="3977579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01109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4840442"/>
            <a:ext cx="6120091" cy="1153708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4840442"/>
            <a:ext cx="6120091" cy="1153708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0787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968092"/>
            <a:ext cx="12420184" cy="351458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4457417"/>
            <a:ext cx="6091964" cy="2184511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6641928"/>
            <a:ext cx="6091964" cy="97692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4457417"/>
            <a:ext cx="6121966" cy="2184511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6641928"/>
            <a:ext cx="6121966" cy="97692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49167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0068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683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212215"/>
            <a:ext cx="4644444" cy="4242753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2618052"/>
            <a:ext cx="7290108" cy="12921875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5454968"/>
            <a:ext cx="4644444" cy="10106002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8946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212215"/>
            <a:ext cx="4644444" cy="4242753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2618052"/>
            <a:ext cx="7290108" cy="12921875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5454968"/>
            <a:ext cx="4644444" cy="10106002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8963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968092"/>
            <a:ext cx="12420184" cy="351458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4840442"/>
            <a:ext cx="12420184" cy="1153708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6853160"/>
            <a:ext cx="3240048" cy="9680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BE5D3-88AA-472C-8759-54A64E04400C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6853160"/>
            <a:ext cx="4860072" cy="9680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6853160"/>
            <a:ext cx="3240048" cy="9680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318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53" r:id="rId1"/>
    <p:sldLayoutId id="2147483854" r:id="rId2"/>
    <p:sldLayoutId id="2147483855" r:id="rId3"/>
    <p:sldLayoutId id="2147483856" r:id="rId4"/>
    <p:sldLayoutId id="2147483857" r:id="rId5"/>
    <p:sldLayoutId id="2147483858" r:id="rId6"/>
    <p:sldLayoutId id="2147483859" r:id="rId7"/>
    <p:sldLayoutId id="2147483860" r:id="rId8"/>
    <p:sldLayoutId id="2147483861" r:id="rId9"/>
    <p:sldLayoutId id="2147483862" r:id="rId10"/>
    <p:sldLayoutId id="2147483863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54">
            <a:extLst>
              <a:ext uri="{FF2B5EF4-FFF2-40B4-BE49-F238E27FC236}">
                <a16:creationId xmlns:a16="http://schemas.microsoft.com/office/drawing/2014/main" id="{40BA8D18-8BC9-4D77-A278-3A8652BA524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567032" y="9178114"/>
            <a:ext cx="4106699" cy="3941464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4F4FDE0C-E346-44E7-9966-12D49165F1F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422830" y="9173871"/>
            <a:ext cx="4106699" cy="3930802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524E10BA-EDC7-4B56-A7BA-CCABBD51D14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42061" y="9156516"/>
            <a:ext cx="4043488" cy="3932352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59DEF67F-BFD0-4D3C-9C37-6D1D7866DBA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753184" y="4932474"/>
            <a:ext cx="4106699" cy="3999320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29A6BC91-BFBC-43EF-8093-240C4DE6BC5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380285" y="4945302"/>
            <a:ext cx="4106698" cy="3913159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E14C1353-DA46-497A-B20E-2B8CACFF3CC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00191" y="4895794"/>
            <a:ext cx="4058712" cy="3979938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05541AA0-7387-4A1A-B495-F0DF2B1EB55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337741" y="715347"/>
            <a:ext cx="4106699" cy="3906147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8BAB301A-68B5-419F-8017-738CDE3276A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873648" y="652170"/>
            <a:ext cx="4106699" cy="3957568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B99C23D4-6748-416F-8F1A-F557831BB983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36248" y="630248"/>
            <a:ext cx="4087442" cy="4024878"/>
          </a:xfrm>
          <a:prstGeom prst="rect">
            <a:avLst/>
          </a:prstGeom>
        </p:spPr>
      </p:pic>
      <p:sp>
        <p:nvSpPr>
          <p:cNvPr id="64" name="TextBox 63">
            <a:extLst>
              <a:ext uri="{FF2B5EF4-FFF2-40B4-BE49-F238E27FC236}">
                <a16:creationId xmlns:a16="http://schemas.microsoft.com/office/drawing/2014/main" id="{69683309-D4C3-42AC-9905-BE740FF22CBF}"/>
              </a:ext>
            </a:extLst>
          </p:cNvPr>
          <p:cNvSpPr txBox="1"/>
          <p:nvPr/>
        </p:nvSpPr>
        <p:spPr>
          <a:xfrm>
            <a:off x="901054" y="542353"/>
            <a:ext cx="5982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A</a:t>
            </a:r>
            <a:endParaRPr lang="zh-CN" altLang="en-US" sz="2400" b="1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63AF7AB-DE84-45B8-A501-4861A9D4FD8F}"/>
              </a:ext>
            </a:extLst>
          </p:cNvPr>
          <p:cNvSpPr txBox="1"/>
          <p:nvPr/>
        </p:nvSpPr>
        <p:spPr>
          <a:xfrm>
            <a:off x="5123690" y="421422"/>
            <a:ext cx="5982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B</a:t>
            </a:r>
            <a:endParaRPr lang="zh-CN" altLang="en-US" sz="2400" b="1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8B19D5CE-36FF-44F7-8410-8E12ED59B8F8}"/>
              </a:ext>
            </a:extLst>
          </p:cNvPr>
          <p:cNvSpPr txBox="1"/>
          <p:nvPr/>
        </p:nvSpPr>
        <p:spPr>
          <a:xfrm>
            <a:off x="9359907" y="542353"/>
            <a:ext cx="5982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C</a:t>
            </a:r>
            <a:endParaRPr lang="zh-CN" altLang="en-US" sz="2400" b="1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E3003E4F-34F6-46D9-B696-CB3CF6E0F134}"/>
              </a:ext>
            </a:extLst>
          </p:cNvPr>
          <p:cNvSpPr txBox="1"/>
          <p:nvPr/>
        </p:nvSpPr>
        <p:spPr>
          <a:xfrm>
            <a:off x="827478" y="4912638"/>
            <a:ext cx="5982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D</a:t>
            </a:r>
            <a:endParaRPr lang="zh-CN" altLang="en-US" sz="2400" b="1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A8ECEACB-A7E8-472C-8A9B-E1F9E7F5A956}"/>
              </a:ext>
            </a:extLst>
          </p:cNvPr>
          <p:cNvSpPr txBox="1"/>
          <p:nvPr/>
        </p:nvSpPr>
        <p:spPr>
          <a:xfrm>
            <a:off x="5233547" y="4790242"/>
            <a:ext cx="5982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E</a:t>
            </a:r>
            <a:endParaRPr lang="zh-CN" altLang="en-US" sz="2400" b="1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FF14BC1B-29BB-4B35-9A65-EF95520518EC}"/>
              </a:ext>
            </a:extLst>
          </p:cNvPr>
          <p:cNvSpPr txBox="1"/>
          <p:nvPr/>
        </p:nvSpPr>
        <p:spPr>
          <a:xfrm>
            <a:off x="9301648" y="4925985"/>
            <a:ext cx="5982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</a:t>
            </a:r>
            <a:endParaRPr lang="zh-CN" altLang="en-US" sz="2400" b="1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9948662C-97C2-49BF-88D3-46DFF988BCE7}"/>
              </a:ext>
            </a:extLst>
          </p:cNvPr>
          <p:cNvSpPr txBox="1"/>
          <p:nvPr/>
        </p:nvSpPr>
        <p:spPr>
          <a:xfrm>
            <a:off x="918416" y="9011834"/>
            <a:ext cx="5982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G</a:t>
            </a:r>
            <a:endParaRPr lang="zh-CN" altLang="en-US" sz="2400" b="1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11D346C5-81A5-46EA-BBB3-EFBC75AB1243}"/>
              </a:ext>
            </a:extLst>
          </p:cNvPr>
          <p:cNvSpPr txBox="1"/>
          <p:nvPr/>
        </p:nvSpPr>
        <p:spPr>
          <a:xfrm>
            <a:off x="5271267" y="9000487"/>
            <a:ext cx="5982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H</a:t>
            </a:r>
            <a:endParaRPr lang="zh-CN" altLang="en-US" sz="2400" b="1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35577E3-5C6F-4704-94A2-6F4E5E698052}"/>
              </a:ext>
            </a:extLst>
          </p:cNvPr>
          <p:cNvSpPr txBox="1"/>
          <p:nvPr/>
        </p:nvSpPr>
        <p:spPr>
          <a:xfrm>
            <a:off x="9444437" y="9005126"/>
            <a:ext cx="5982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I</a:t>
            </a:r>
            <a:endParaRPr lang="zh-CN" altLang="en-US" sz="24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6F852D0E-1286-42A2-9FF0-E821A2AF4393}"/>
              </a:ext>
            </a:extLst>
          </p:cNvPr>
          <p:cNvSpPr txBox="1"/>
          <p:nvPr/>
        </p:nvSpPr>
        <p:spPr>
          <a:xfrm>
            <a:off x="563111" y="13929902"/>
            <a:ext cx="13293496" cy="37856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20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ure S5. </a:t>
            </a:r>
            <a:r>
              <a:rPr lang="en-US" altLang="zh-CN" sz="2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etabolites markers for pairwise discriminations of </a:t>
            </a:r>
            <a:r>
              <a:rPr lang="en-US" altLang="zh-CN" sz="20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RC, CRA and NC groups </a:t>
            </a:r>
            <a:r>
              <a:rPr lang="en-US" altLang="zh-CN" sz="2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with adjustment of age, gender and obesity.</a:t>
            </a:r>
            <a:r>
              <a:rPr lang="en-US" altLang="zh-CN" sz="20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20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A)</a:t>
            </a:r>
            <a:r>
              <a:rPr lang="en-US" altLang="zh-CN" sz="20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eceiver operating characteristic (ROC) analysis for the 20 metabolites markers discriminating CRC from NC with age, gender and obesity. </a:t>
            </a:r>
            <a:r>
              <a:rPr lang="en-US" altLang="zh-CN" sz="20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B)</a:t>
            </a:r>
            <a:r>
              <a:rPr lang="en-US" altLang="zh-CN" sz="2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ROC analysis applying the 20 CRC vs NC metabolites markers with age, gender and obesity to discriminate CRA from NC. </a:t>
            </a:r>
            <a:r>
              <a:rPr lang="en-US" altLang="zh-CN" sz="20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C)</a:t>
            </a:r>
            <a:r>
              <a:rPr lang="en-US" altLang="zh-CN" sz="2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ROC analysis applying the 20 CRC vs NC metabolites markers with age, gender and obesity to discriminate CRC from CRA. </a:t>
            </a:r>
            <a:r>
              <a:rPr lang="en-US" altLang="zh-CN" sz="20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D)</a:t>
            </a:r>
            <a:r>
              <a:rPr lang="en-US" altLang="zh-CN" sz="20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OC analysis for the 11 metabolites markers with age, gender and obesity discriminating CRA from NC. </a:t>
            </a:r>
            <a:r>
              <a:rPr lang="en-US" altLang="zh-CN" sz="20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E)</a:t>
            </a:r>
            <a:r>
              <a:rPr lang="en-US" altLang="zh-CN" sz="2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ROC analysis applying the 11 CRA vs NC metabolites markers with age, gender and obesity to discriminate CRC from NC. </a:t>
            </a:r>
            <a:r>
              <a:rPr lang="en-US" altLang="zh-CN" sz="20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F)</a:t>
            </a:r>
            <a:r>
              <a:rPr lang="en-US" altLang="zh-CN" sz="2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ROC analysis applying the 11 CRA vs NC metabolites markers with age, gender and obesity to discriminate CRC from CRA. </a:t>
            </a:r>
            <a:r>
              <a:rPr lang="en-US" altLang="zh-CN" sz="20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G)</a:t>
            </a:r>
            <a:r>
              <a:rPr lang="en-US" altLang="zh-CN" sz="20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OC analysis for the 13 metabolites markers with age, gender and obesity discriminating CRC from CRA. </a:t>
            </a:r>
            <a:r>
              <a:rPr lang="en-US" altLang="zh-CN" sz="20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H)</a:t>
            </a:r>
            <a:r>
              <a:rPr lang="en-US" altLang="zh-CN" sz="2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ROC analysis applying the 13 CRC vs CRA metabolites markers with age, gender and obesity to discriminate CRC from NC. </a:t>
            </a:r>
            <a:r>
              <a:rPr lang="en-US" altLang="zh-CN" sz="20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I)</a:t>
            </a:r>
            <a:r>
              <a:rPr lang="en-US" altLang="zh-CN" sz="2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ROC analysis applying the 13 CRC vs CRA metabolites markers with age, gender and obesity to discriminate CRA from NC.  </a:t>
            </a:r>
            <a:r>
              <a:rPr lang="en-HK" altLang="zh-CN" sz="2000" kern="0" dirty="0">
                <a:solidFill>
                  <a:srgbClr val="202124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RC; colorectal cancer, CRA; colorectal adenoma, NC; normal control.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D380C3F2-2275-4C8C-9432-8BC4578DF5FF}"/>
              </a:ext>
            </a:extLst>
          </p:cNvPr>
          <p:cNvSpPr txBox="1"/>
          <p:nvPr/>
        </p:nvSpPr>
        <p:spPr>
          <a:xfrm>
            <a:off x="5123693" y="13227305"/>
            <a:ext cx="541589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/>
              <a:t>False Positive Percentage (%)</a:t>
            </a:r>
            <a:endParaRPr lang="zh-CN" altLang="en-US" sz="2800" b="1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098783E-301F-4F40-8AD0-C8395F1CF24D}"/>
              </a:ext>
            </a:extLst>
          </p:cNvPr>
          <p:cNvSpPr txBox="1"/>
          <p:nvPr/>
        </p:nvSpPr>
        <p:spPr>
          <a:xfrm rot="16200000">
            <a:off x="-2338119" y="7173610"/>
            <a:ext cx="58586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/>
              <a:t>True Positive Percentage (%)</a:t>
            </a:r>
            <a:endParaRPr lang="zh-CN" alt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3972702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2</TotalTime>
  <Words>275</Words>
  <Application>Microsoft Macintosh PowerPoint</Application>
  <PresentationFormat>Custom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gan Liu</dc:creator>
  <cp:lastModifiedBy>Olabisi Coker</cp:lastModifiedBy>
  <cp:revision>55</cp:revision>
  <dcterms:created xsi:type="dcterms:W3CDTF">2020-10-05T01:00:00Z</dcterms:created>
  <dcterms:modified xsi:type="dcterms:W3CDTF">2021-10-25T04:05:21Z</dcterms:modified>
</cp:coreProperties>
</file>